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78538CD2-2593-4D5B-99C4-4BD6D545CCD0}" v="144" dt="2021-11-17T17:57:35.249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22" d="100"/>
          <a:sy n="122" d="100"/>
        </p:scale>
        <p:origin x="9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Post, Frank" userId="cc541953-8f62-4513-9ab9-647a04022e4c" providerId="ADAL" clId="{72E1E61C-E589-42F1-921F-09B64515FDA8}"/>
    <pc:docChg chg="delSld">
      <pc:chgData name="Post, Frank" userId="cc541953-8f62-4513-9ab9-647a04022e4c" providerId="ADAL" clId="{72E1E61C-E589-42F1-921F-09B64515FDA8}" dt="2021-11-17T18:03:32.133" v="0" actId="47"/>
      <pc:docMkLst>
        <pc:docMk/>
      </pc:docMkLst>
      <pc:sldChg chg="del">
        <pc:chgData name="Post, Frank" userId="cc541953-8f62-4513-9ab9-647a04022e4c" providerId="ADAL" clId="{72E1E61C-E589-42F1-921F-09B64515FDA8}" dt="2021-11-17T18:03:32.133" v="0" actId="47"/>
        <pc:sldMkLst>
          <pc:docMk/>
          <pc:sldMk cId="1715907804" sldId="256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25D08959-5DC7-4D79-8946-211F6F9BCF7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355735DB-8263-4E14-9D92-6F336D0FA9F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5ADEC76C-8487-4D7A-8022-F6EE87B781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F08E23-8C02-4612-9BD3-B4E05379FAC1}" type="datetimeFigureOut">
              <a:rPr lang="en-GB" smtClean="0"/>
              <a:t>23/11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7BD7F967-C7D1-4459-9F8B-A1E7993068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0204603F-0CE1-4F04-A3A4-434F92D115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5D71E0-6DC5-4D18-B0CB-D914EE0EF2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28959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30563A8C-60D7-4463-AAA5-874387C03A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C4DF4FA1-5F56-4E60-BF42-69975DBF2FD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E3A8F23F-CA9D-4B4B-8A66-2AA37E4A0C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F08E23-8C02-4612-9BD3-B4E05379FAC1}" type="datetimeFigureOut">
              <a:rPr lang="en-GB" smtClean="0"/>
              <a:t>23/11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B4AFC415-CC3C-446B-B38C-A180964A20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05E08001-E241-4D6E-AD5D-808395454D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5D71E0-6DC5-4D18-B0CB-D914EE0EF2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356077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89642E1F-8BBD-4ED8-B2BD-1E12BE67B45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0131EAB2-B988-4EE4-BCEB-727C24D9BF7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6795352F-B3D3-4044-8D68-9EB820DE6F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F08E23-8C02-4612-9BD3-B4E05379FAC1}" type="datetimeFigureOut">
              <a:rPr lang="en-GB" smtClean="0"/>
              <a:t>23/11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F5E47169-6E8C-4518-90D5-E13A06676E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BA3A4C46-9DF8-4A71-8F99-7073E46909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5D71E0-6DC5-4D18-B0CB-D914EE0EF2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605640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8AF590E7-7ACB-49FD-8639-62F9635B79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88110976-179D-4079-B735-9AEDBE4AFBF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1407443A-1931-4A46-B572-552BAEC460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F08E23-8C02-4612-9BD3-B4E05379FAC1}" type="datetimeFigureOut">
              <a:rPr lang="en-GB" smtClean="0"/>
              <a:t>23/11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B40484D1-8562-4064-8B1C-33B65130D4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FE5A02AD-D05F-4B26-94A5-BF0483DB1B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5D71E0-6DC5-4D18-B0CB-D914EE0EF2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544738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EBC6AF19-3793-4CBC-8198-531A05A92D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0ACA5423-9ACE-4089-A5B3-6B982F870DD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B0B23692-7412-40FE-851D-65847332CC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F08E23-8C02-4612-9BD3-B4E05379FAC1}" type="datetimeFigureOut">
              <a:rPr lang="en-GB" smtClean="0"/>
              <a:t>23/11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B266DAAB-FAD3-4A88-8ACA-96051EA25B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294D5320-5877-4C1C-8CD4-D7D3176E26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5D71E0-6DC5-4D18-B0CB-D914EE0EF2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011600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CA363FDD-69B5-4F3E-98AD-64E14A1666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3B4ED5B9-FA35-40BD-8AB0-ACCA3806098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6B6C2F33-B0E6-4CA0-BD05-ABC7DEF780C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F4C2FB2D-66E2-401C-9B98-48BDBA29E4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F08E23-8C02-4612-9BD3-B4E05379FAC1}" type="datetimeFigureOut">
              <a:rPr lang="en-GB" smtClean="0"/>
              <a:t>23/11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71C1AB08-F0B9-4AC2-9BD0-2FF5693F3B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D7F5AF44-72C7-4E11-9F40-EE18932A1A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5D71E0-6DC5-4D18-B0CB-D914EE0EF2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345397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932E2B3C-AAE5-40B4-B707-6CFE63C589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743B174B-2314-4FD2-8DD3-8CB92EB3BA2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AB791FEC-D22D-493C-BAB8-3B3B52EE094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EA148DE2-412C-49A4-BEB4-7B29EF645E1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272088E6-0467-4A04-B902-B7BC67E39D0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5878A90F-CDA4-4CD9-B6FB-430A1BF6BD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F08E23-8C02-4612-9BD3-B4E05379FAC1}" type="datetimeFigureOut">
              <a:rPr lang="en-GB" smtClean="0"/>
              <a:t>23/11/2021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0DECD6F1-F856-4529-A310-44F907474B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708A7CBA-CB73-47D8-8EB2-363C82D804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5D71E0-6DC5-4D18-B0CB-D914EE0EF2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070213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EEABC634-FC23-45B8-874C-6388ED351C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99F65312-829B-4E5A-A3FB-55034D5174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F08E23-8C02-4612-9BD3-B4E05379FAC1}" type="datetimeFigureOut">
              <a:rPr lang="en-GB" smtClean="0"/>
              <a:t>23/11/2021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40D66C23-ECD2-4BFD-80F4-07B1FF1DBA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A5F8D640-1AB6-470B-8C49-75E12E0F94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5D71E0-6DC5-4D18-B0CB-D914EE0EF2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86915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2D1F7F78-D00E-411E-9699-768D5C49F6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F08E23-8C02-4612-9BD3-B4E05379FAC1}" type="datetimeFigureOut">
              <a:rPr lang="en-GB" smtClean="0"/>
              <a:t>23/11/2021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289E60A7-11CA-4C75-95DE-CE1BF4F00E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203BA489-5626-4CDF-AEE4-0AF02AC57D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5D71E0-6DC5-4D18-B0CB-D914EE0EF2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018468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5BF3CEAC-628A-4D3F-B185-FD5BF36175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455405DD-94F2-4780-BACE-B88C3699BA0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C92E4309-6799-48FE-85F5-048C3C432CC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57F6AF98-C6D6-4522-A0F6-348F296B40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F08E23-8C02-4612-9BD3-B4E05379FAC1}" type="datetimeFigureOut">
              <a:rPr lang="en-GB" smtClean="0"/>
              <a:t>23/11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DC7E8896-4A0B-402F-AFCF-AD8EDE97F8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B1C64D6E-A610-433B-9F95-6B45E148A1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5D71E0-6DC5-4D18-B0CB-D914EE0EF2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075292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EB8C945E-6996-4C8C-B44E-280B794D6A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5900B6AA-AD5E-4C8F-8CA8-DC45E250B79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8003DA91-B388-491B-8D26-E3AD69191F7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0C860B7F-37C2-4A46-B939-999ECD8B64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F08E23-8C02-4612-9BD3-B4E05379FAC1}" type="datetimeFigureOut">
              <a:rPr lang="en-GB" smtClean="0"/>
              <a:t>23/11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E7B65B34-6FFF-4141-BD50-584303068F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8A0151DD-B687-494F-BBC5-14EC0975A3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5D71E0-6DC5-4D18-B0CB-D914EE0EF2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375379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9BB9E26B-EA0E-4EEE-B485-AA8357C063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D241F0F8-77B9-44AC-B339-9D123B6B7E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570932A4-3CB1-47C6-BD4B-4A1D47BD113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F08E23-8C02-4612-9BD3-B4E05379FAC1}" type="datetimeFigureOut">
              <a:rPr lang="en-GB" smtClean="0"/>
              <a:t>23/11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F113F881-23D7-47B2-BE24-92FD19C7069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84118750-19C8-442A-AC60-7078B6499A9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5D71E0-6DC5-4D18-B0CB-D914EE0EF2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242667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666447" y="5914239"/>
            <a:ext cx="8258721" cy="2899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1	Prevalence of sickle cell trait, </a:t>
            </a:r>
            <a:r>
              <a:rPr lang="en-GB" sz="12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POL1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high-risk genotypes and </a:t>
            </a:r>
            <a:r>
              <a:rPr lang="en-GB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GFR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by country of ancestry</a:t>
            </a:r>
            <a:endParaRPr lang="en-GB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82496" y="1094232"/>
            <a:ext cx="8827008" cy="46695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279270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3</TotalTime>
  <Words>2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ost, Frank</dc:creator>
  <cp:lastModifiedBy>Francis Chua</cp:lastModifiedBy>
  <cp:revision>4</cp:revision>
  <dcterms:created xsi:type="dcterms:W3CDTF">2021-06-30T16:11:29Z</dcterms:created>
  <dcterms:modified xsi:type="dcterms:W3CDTF">2021-11-23T13:15:06Z</dcterms:modified>
</cp:coreProperties>
</file>